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4C0599-AAF3-4906-8F3F-4EC47F69FD1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342ED7-DC06-4183-9609-AB62A566800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AE876-A36F-4009-A4AA-8CDEEDC6C5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5E552-9035-472B-91E3-8265EA2CD3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3A63E-3DF4-469D-AE0C-BD64FC2E75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8B1FD-49A8-45EA-8809-6573E9C6849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AACDFD-4420-48C2-AAA3-CEF752EBC7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47ED5-A9AF-46C5-B4B2-519ABC8FF2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580A6-C690-474C-8A63-8F78E96B04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66346-446B-4606-A413-F3D7A4AAF1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37DBC1-C481-44DD-A34E-057C4AAA2E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ED701-28EF-4E3B-ADE3-0F48FFF8D1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36538E-1C7A-4DC2-81A3-0778A21060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489D7-807B-41CE-A9A5-F5549F16AE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4B1C08-2F6A-4BBC-914C-3C379A79D12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59"/>
          <p:cNvSpPr/>
          <p:nvPr/>
        </p:nvSpPr>
        <p:spPr>
          <a:xfrm>
            <a:off x="1800" y="0"/>
            <a:ext cx="7534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Chart 95" descr=""/>
          <p:cNvPicPr/>
          <p:nvPr/>
        </p:nvPicPr>
        <p:blipFill>
          <a:blip r:embed="rId1"/>
          <a:stretch/>
        </p:blipFill>
        <p:spPr>
          <a:xfrm>
            <a:off x="774720" y="298440"/>
            <a:ext cx="5315040" cy="2365560"/>
          </a:xfrm>
          <a:prstGeom prst="rect">
            <a:avLst/>
          </a:prstGeom>
          <a:ln w="0">
            <a:noFill/>
          </a:ln>
        </p:spPr>
      </p:pic>
      <p:sp>
        <p:nvSpPr>
          <p:cNvPr id="50" name="TextBox 1"/>
          <p:cNvSpPr/>
          <p:nvPr/>
        </p:nvSpPr>
        <p:spPr>
          <a:xfrm>
            <a:off x="117360" y="7432560"/>
            <a:ext cx="66452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 Activation of IFN signaling pathway in parental MCF-7 and AI-resistant MCF-7:5C cells in response to IFN-</a:t>
            </a:r>
            <a:r>
              <a:rPr b="1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F-7 and MCF-7:5C cells were treated with 100 U/mL IFN-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harvested at the indicated time points. mRNA expression of IFITM1, PLSCR1 and STAT1was measured using RT-PCR and calculated using the 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ΔΔ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 method relative to PUM1. mRNA expression is given as fold change over control (time zero). Values shown are means of triplicate measurements ± SD from three independent experiment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Chart 6" descr=""/>
          <p:cNvPicPr/>
          <p:nvPr/>
        </p:nvPicPr>
        <p:blipFill>
          <a:blip r:embed="rId2"/>
          <a:stretch/>
        </p:blipFill>
        <p:spPr>
          <a:xfrm>
            <a:off x="1030320" y="2548080"/>
            <a:ext cx="5126040" cy="2474640"/>
          </a:xfrm>
          <a:prstGeom prst="rect">
            <a:avLst/>
          </a:prstGeom>
          <a:ln w="0">
            <a:noFill/>
          </a:ln>
        </p:spPr>
      </p:pic>
      <p:pic>
        <p:nvPicPr>
          <p:cNvPr id="52" name="Chart 7" descr=""/>
          <p:cNvPicPr/>
          <p:nvPr/>
        </p:nvPicPr>
        <p:blipFill>
          <a:blip r:embed="rId3"/>
          <a:stretch/>
        </p:blipFill>
        <p:spPr>
          <a:xfrm>
            <a:off x="1060560" y="4857840"/>
            <a:ext cx="5127480" cy="2469960"/>
          </a:xfrm>
          <a:prstGeom prst="rect">
            <a:avLst/>
          </a:prstGeom>
          <a:ln w="0">
            <a:noFill/>
          </a:ln>
        </p:spPr>
      </p:pic>
      <p:sp>
        <p:nvSpPr>
          <p:cNvPr id="53" name="TextBox 56"/>
          <p:cNvSpPr/>
          <p:nvPr/>
        </p:nvSpPr>
        <p:spPr>
          <a:xfrm>
            <a:off x="5894640" y="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oi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8T22:58:20Z</dcterms:created>
  <dc:creator>Windows User</dc:creator>
  <dc:description/>
  <dc:language>en-US</dc:language>
  <cp:lastModifiedBy>Windows User</cp:lastModifiedBy>
  <dcterms:modified xsi:type="dcterms:W3CDTF">2014-10-08T22:58:47Z</dcterms:modified>
  <cp:revision>1</cp:revision>
  <dc:subject/>
  <dc:title>PowerPoint Presentation</dc:title>
</cp:coreProperties>
</file>